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696" y="88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314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7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831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35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60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265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686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94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807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148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0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470D8-F7A5-4A6D-80E1-7D6782A02A46}" type="datetimeFigureOut">
              <a:rPr lang="en-US" smtClean="0"/>
              <a:t>4/17/2025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C9215-081A-4581-A0C9-14D5E063600B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855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FD5D425-42F0-4B1C-A56D-C9FE63A7216F}"/>
              </a:ext>
            </a:extLst>
          </p:cNvPr>
          <p:cNvSpPr txBox="1"/>
          <p:nvPr/>
        </p:nvSpPr>
        <p:spPr>
          <a:xfrm>
            <a:off x="732711" y="96892"/>
            <a:ext cx="100283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ure S5: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verall prevalence of 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s-level and multi-drug resistance (MDR) in all samples. Bars represent 95% confidence interval (CI).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ggetto 2">
            <a:extLst>
              <a:ext uri="{FF2B5EF4-FFF2-40B4-BE49-F238E27FC236}">
                <a16:creationId xmlns:a16="http://schemas.microsoft.com/office/drawing/2014/main" id="{B0DB2093-B927-4D7C-B9F3-C7CA5A9526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5243575"/>
              </p:ext>
            </p:extLst>
          </p:nvPr>
        </p:nvGraphicFramePr>
        <p:xfrm>
          <a:off x="4101626" y="545513"/>
          <a:ext cx="3987160" cy="62733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Prism 10" r:id="rId3" imgW="2995969" imgH="4712657" progId="Prism10.Document">
                  <p:embed/>
                </p:oleObj>
              </mc:Choice>
              <mc:Fallback>
                <p:oleObj name="Prism 10" r:id="rId3" imgW="2995969" imgH="471265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01626" y="545513"/>
                        <a:ext cx="3987160" cy="62733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734206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i Office</vt:lpstr>
      <vt:lpstr>Prism 10</vt:lpstr>
      <vt:lpstr>Presentazione standard di PowerPoint</vt:lpstr>
    </vt:vector>
  </TitlesOfParts>
  <Company>Università degli Studi di Pado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coni Andrea</dc:creator>
  <cp:lastModifiedBy>Andrea Laconi</cp:lastModifiedBy>
  <cp:revision>25</cp:revision>
  <dcterms:created xsi:type="dcterms:W3CDTF">2022-03-15T12:01:40Z</dcterms:created>
  <dcterms:modified xsi:type="dcterms:W3CDTF">2025-04-17T12:54:31Z</dcterms:modified>
</cp:coreProperties>
</file>